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notesMasterIdLst>
    <p:notesMasterId r:id="rId4"/>
  </p:notesMasterIdLst>
  <p:sldIdLst>
    <p:sldId id="370" r:id="rId2"/>
    <p:sldId id="354" r:id="rId3"/>
  </p:sldIdLst>
  <p:sldSz cx="7772400" cy="10058400"/>
  <p:notesSz cx="7023100" cy="9309100"/>
  <p:custDataLst>
    <p:tags r:id="rId5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8BDD3"/>
    <a:srgbClr val="BDD3D3"/>
    <a:srgbClr val="856D9D"/>
    <a:srgbClr val="6D9D9D"/>
    <a:srgbClr val="CCFFFF"/>
    <a:srgbClr val="E6E6E6"/>
    <a:srgbClr val="317CC1"/>
    <a:srgbClr val="79ADDD"/>
    <a:srgbClr val="ADCDEA"/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10" autoAdjust="0"/>
    <p:restoredTop sz="94660"/>
  </p:normalViewPr>
  <p:slideViewPr>
    <p:cSldViewPr snapToGrid="0">
      <p:cViewPr>
        <p:scale>
          <a:sx n="100" d="100"/>
          <a:sy n="100" d="100"/>
        </p:scale>
        <p:origin x="2124" y="-14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33" d="100"/>
        <a:sy n="33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43979" cy="467363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7531" y="0"/>
            <a:ext cx="3043979" cy="467363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r">
              <a:defRPr sz="1200"/>
            </a:lvl1pPr>
          </a:lstStyle>
          <a:p>
            <a:fld id="{B165C8F5-16F2-45EF-847E-B90D7AD0259E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7113" y="1163638"/>
            <a:ext cx="24288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77" tIns="45789" rIns="91577" bIns="457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946" y="4479687"/>
            <a:ext cx="5617208" cy="3665776"/>
          </a:xfrm>
          <a:prstGeom prst="rect">
            <a:avLst/>
          </a:prstGeom>
        </p:spPr>
        <p:txBody>
          <a:bodyPr vert="horz" lIns="91577" tIns="45789" rIns="91577" bIns="457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41738"/>
            <a:ext cx="3043979" cy="467363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7531" y="8841738"/>
            <a:ext cx="3043979" cy="467363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r">
              <a:defRPr sz="1200"/>
            </a:lvl1pPr>
          </a:lstStyle>
          <a:p>
            <a:fld id="{B6F63300-A187-4143-9830-B1391A8D4A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3320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687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67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284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571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682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368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501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803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600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992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695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5F78B7-3D03-4F6B-80C4-35D543C9675A}" type="datetimeFigureOut">
              <a:rPr lang="en-US" smtClean="0"/>
              <a:t>4/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DFDAC-390D-423B-B0E2-65B91B1C11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5228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248782F-D8FC-5AA5-4BE6-293C707F3529}"/>
              </a:ext>
            </a:extLst>
          </p:cNvPr>
          <p:cNvSpPr txBox="1"/>
          <p:nvPr/>
        </p:nvSpPr>
        <p:spPr>
          <a:xfrm>
            <a:off x="916686" y="5657334"/>
            <a:ext cx="5939028" cy="138499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2 Fig. 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cipenserid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erpesvirus 3 genome features at the terminal ends of the unique (U) region. 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) Sequences at the U region termini are provided for each contig with the terminal nucleotide shown in bold.  The underlined residues form the inverted repeat displayed in B.  B) A schematic of the inverted repeat composed of reverse complement counterparts located at each end of the U region.  The repeat length was 12 (TT), 13 (TA) or 20 (CA) bp depending on which nucleotides were present at the 5’ terminal end of the U region.  C) Tandem direct repeat sequences (blue arrows) which include the inverted repeat (underlined) at the U 3’ terminal end. </a:t>
            </a:r>
            <a:r>
              <a:rPr kumimoji="0" lang="en-US" sz="10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quence is adjacent to perfect and/or imperfect TTAGGG hexamers; </a:t>
            </a:r>
            <a:r>
              <a:rPr kumimoji="0" lang="en-US" sz="10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RR2 is absent, and the U region is adjoining host sequence; </a:t>
            </a:r>
            <a:r>
              <a:rPr kumimoji="0" lang="en-US" sz="10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version of sequence blocks at 5’and 3’ ends of the U region.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+mn-cs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B7B1721-7C23-BA43-0D01-97AD99A4CC49}"/>
              </a:ext>
            </a:extLst>
          </p:cNvPr>
          <p:cNvSpPr txBox="1"/>
          <p:nvPr/>
        </p:nvSpPr>
        <p:spPr>
          <a:xfrm>
            <a:off x="916686" y="7193875"/>
            <a:ext cx="593902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Any use of trade, firm, or product names is for descriptive purposes only and does not imply endorsement by the U.S. Government.</a:t>
            </a:r>
            <a:r>
              <a:rPr lang="en-US" sz="800" dirty="0"/>
              <a:t>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E8BFD2F-FA63-7D7E-15E9-07006945F8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9112" y="2600236"/>
            <a:ext cx="6734175" cy="2981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3227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>
            <a:extLst>
              <a:ext uri="{FF2B5EF4-FFF2-40B4-BE49-F238E27FC236}">
                <a16:creationId xmlns:a16="http://schemas.microsoft.com/office/drawing/2014/main" id="{52AEBB5C-174E-2854-65FD-F1110A9EDC10}"/>
              </a:ext>
            </a:extLst>
          </p:cNvPr>
          <p:cNvSpPr txBox="1"/>
          <p:nvPr/>
        </p:nvSpPr>
        <p:spPr>
          <a:xfrm>
            <a:off x="728616" y="174771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C2AA40C-5A7A-0423-03A3-32DD9730951C}"/>
              </a:ext>
            </a:extLst>
          </p:cNvPr>
          <p:cNvSpPr txBox="1"/>
          <p:nvPr/>
        </p:nvSpPr>
        <p:spPr>
          <a:xfrm>
            <a:off x="728616" y="4377542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C77B97B-5C9A-6039-0536-FC9B14B707DD}"/>
              </a:ext>
            </a:extLst>
          </p:cNvPr>
          <p:cNvSpPr txBox="1"/>
          <p:nvPr/>
        </p:nvSpPr>
        <p:spPr>
          <a:xfrm>
            <a:off x="728616" y="6947053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064EFB6-6855-7904-519B-08C247FC6A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2606" y="7080089"/>
            <a:ext cx="6062998" cy="39322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0762B78-7DB0-DD38-AD70-4253F94256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7690" y="4516058"/>
            <a:ext cx="4307685" cy="265869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CDB064C-9A42-5516-6FBD-4E048E345B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6465" y="1873324"/>
            <a:ext cx="5594784" cy="261175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759F2C8-1BD2-D0E6-4F89-57FDD7BA9437}"/>
              </a:ext>
            </a:extLst>
          </p:cNvPr>
          <p:cNvSpPr txBox="1"/>
          <p:nvPr/>
        </p:nvSpPr>
        <p:spPr>
          <a:xfrm>
            <a:off x="737690" y="7618189"/>
            <a:ext cx="6197914" cy="161582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2 Fig  </a:t>
            </a:r>
            <a:r>
              <a:rPr kumimoji="0" lang="en-US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cipenserid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erpesvirus 3 genome features at the terminal ends of the unique (U) region.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) Sequences at the U region termini are provided for each contig with the terminal nucleotide shown in bold.  The underlined residues form the inverted repeat displayed in B.  B) A schematic of the inverted repeat composed of reverse complement counterparts located at each end of the U region.  The repeat length was 12 (TT), 13 (TA) or 20 (CA) bp depending on which nucleotides were present at the 5’ terminal end of the U region.  C) Tandem direct repeat sequences (blue arrows) which include the inverted repeat (underlined) at the U 3’ terminal end. 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equence is adjacent to perfect and/or imperfect TTAGGG hexamers; 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RR2 is absent, and the U region is adjoining host sequence; </a:t>
            </a:r>
            <a:r>
              <a:rPr kumimoji="0" lang="en-US" sz="1100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version of sequence blocks at 5’and 3’ ends of the U region. </a:t>
            </a: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32651867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NGAGE" val="{&quot;SavedSwatch&quot;:&quot;-14272694|-12223080|-16154294|-9539986|-16777216|Fisheries and Oceans Canada&quot;,&quot;Id&quot;:&quot;671acc214542454144541a25&quot;,&quot;SmartGridHorizontal&quot;:0,&quot;LinkedExcelSources&quot;:{},&quot;LinkedProjectSources&quot;:{},&quot;FlowConfig&quot;:{&quot;Canvas&quot;:{&quot;Slide&quot;:-1,&quot;Width&quot;:0,&quot;Height&quot;:0},&quot;Timeline&quot;:{&quot;Actions&quot;:[]}},&quot;LinkedSlideMergeSources&quot;:{},&quot;LinkedSharePointSlideMergeSources&quot;:{}}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3676</TotalTime>
  <Words>378</Words>
  <Application>Microsoft Office PowerPoint</Application>
  <PresentationFormat>Custom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outhier, Sharon C</dc:creator>
  <cp:lastModifiedBy>Clouthier, Sharon (DFO/MPO)</cp:lastModifiedBy>
  <cp:revision>520</cp:revision>
  <cp:lastPrinted>2024-10-24T16:54:55Z</cp:lastPrinted>
  <dcterms:created xsi:type="dcterms:W3CDTF">2022-05-24T14:12:10Z</dcterms:created>
  <dcterms:modified xsi:type="dcterms:W3CDTF">2025-04-04T14:11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1bfb733f-faef-464c-9b6d-731b56f94973_Enabled">
    <vt:lpwstr>true</vt:lpwstr>
  </property>
  <property fmtid="{D5CDD505-2E9C-101B-9397-08002B2CF9AE}" pid="3" name="MSIP_Label_1bfb733f-faef-464c-9b6d-731b56f94973_SetDate">
    <vt:lpwstr>2022-05-24T15:22:22Z</vt:lpwstr>
  </property>
  <property fmtid="{D5CDD505-2E9C-101B-9397-08002B2CF9AE}" pid="4" name="MSIP_Label_1bfb733f-faef-464c-9b6d-731b56f94973_Method">
    <vt:lpwstr>Standard</vt:lpwstr>
  </property>
  <property fmtid="{D5CDD505-2E9C-101B-9397-08002B2CF9AE}" pid="5" name="MSIP_Label_1bfb733f-faef-464c-9b6d-731b56f94973_Name">
    <vt:lpwstr>Unclass - Non-Classifié</vt:lpwstr>
  </property>
  <property fmtid="{D5CDD505-2E9C-101B-9397-08002B2CF9AE}" pid="6" name="MSIP_Label_1bfb733f-faef-464c-9b6d-731b56f94973_SiteId">
    <vt:lpwstr>1594fdae-a1d9-4405-915d-011467234338</vt:lpwstr>
  </property>
  <property fmtid="{D5CDD505-2E9C-101B-9397-08002B2CF9AE}" pid="7" name="MSIP_Label_1bfb733f-faef-464c-9b6d-731b56f94973_ActionId">
    <vt:lpwstr>f5e54c20-300d-40cb-8492-0000c313632c</vt:lpwstr>
  </property>
</Properties>
</file>